
<file path=[Content_Types].xml><?xml version="1.0" encoding="utf-8"?>
<Types xmlns="http://schemas.openxmlformats.org/package/2006/content-types">
  <Default Extension="png" ContentType="image/png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napToGrid="0">
      <p:cViewPr>
        <p:scale>
          <a:sx n="140" d="100"/>
          <a:sy n="140" d="100"/>
        </p:scale>
        <p:origin x="-1134" y="132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DE992-9680-496D-8D25-F4CE32D29A2E}" type="datetimeFigureOut">
              <a:rPr lang="fr-FR" smtClean="0"/>
              <a:t>26/08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A0D71-B009-420B-AEDF-689EA78E29B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58495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DE992-9680-496D-8D25-F4CE32D29A2E}" type="datetimeFigureOut">
              <a:rPr lang="fr-FR" smtClean="0"/>
              <a:t>26/08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A0D71-B009-420B-AEDF-689EA78E29B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086150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DE992-9680-496D-8D25-F4CE32D29A2E}" type="datetimeFigureOut">
              <a:rPr lang="fr-FR" smtClean="0"/>
              <a:t>26/08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A0D71-B009-420B-AEDF-689EA78E29B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992636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DE992-9680-496D-8D25-F4CE32D29A2E}" type="datetimeFigureOut">
              <a:rPr lang="fr-FR" smtClean="0"/>
              <a:t>26/08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A0D71-B009-420B-AEDF-689EA78E29B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945343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DE992-9680-496D-8D25-F4CE32D29A2E}" type="datetimeFigureOut">
              <a:rPr lang="fr-FR" smtClean="0"/>
              <a:t>26/08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A0D71-B009-420B-AEDF-689EA78E29B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062767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DE992-9680-496D-8D25-F4CE32D29A2E}" type="datetimeFigureOut">
              <a:rPr lang="fr-FR" smtClean="0"/>
              <a:t>26/08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A0D71-B009-420B-AEDF-689EA78E29B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093051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DE992-9680-496D-8D25-F4CE32D29A2E}" type="datetimeFigureOut">
              <a:rPr lang="fr-FR" smtClean="0"/>
              <a:t>26/08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A0D71-B009-420B-AEDF-689EA78E29B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02009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DE992-9680-496D-8D25-F4CE32D29A2E}" type="datetimeFigureOut">
              <a:rPr lang="fr-FR" smtClean="0"/>
              <a:t>26/08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A0D71-B009-420B-AEDF-689EA78E29B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63417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DE992-9680-496D-8D25-F4CE32D29A2E}" type="datetimeFigureOut">
              <a:rPr lang="fr-FR" smtClean="0"/>
              <a:t>26/08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A0D71-B009-420B-AEDF-689EA78E29B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060077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DE992-9680-496D-8D25-F4CE32D29A2E}" type="datetimeFigureOut">
              <a:rPr lang="fr-FR" smtClean="0"/>
              <a:t>26/08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A0D71-B009-420B-AEDF-689EA78E29B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449368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DE992-9680-496D-8D25-F4CE32D29A2E}" type="datetimeFigureOut">
              <a:rPr lang="fr-FR" smtClean="0"/>
              <a:t>26/08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A0D71-B009-420B-AEDF-689EA78E29B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340942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1DE992-9680-496D-8D25-F4CE32D29A2E}" type="datetimeFigureOut">
              <a:rPr lang="fr-FR" smtClean="0"/>
              <a:t>26/08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4A0D71-B009-420B-AEDF-689EA78E29B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279900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37" t="20861" r="18238" b="8200"/>
          <a:stretch/>
        </p:blipFill>
        <p:spPr bwMode="auto">
          <a:xfrm>
            <a:off x="107504" y="287689"/>
            <a:ext cx="8398140" cy="43964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Rectangle 1"/>
          <p:cNvSpPr/>
          <p:nvPr/>
        </p:nvSpPr>
        <p:spPr>
          <a:xfrm>
            <a:off x="0" y="287689"/>
            <a:ext cx="827504" cy="20363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" name="Accolade fermante 3"/>
          <p:cNvSpPr/>
          <p:nvPr/>
        </p:nvSpPr>
        <p:spPr>
          <a:xfrm>
            <a:off x="5812532" y="639205"/>
            <a:ext cx="216024" cy="122400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ZoneTexte 4"/>
          <p:cNvSpPr txBox="1"/>
          <p:nvPr/>
        </p:nvSpPr>
        <p:spPr>
          <a:xfrm>
            <a:off x="6033864" y="1090658"/>
            <a:ext cx="12241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ade B</a:t>
            </a:r>
            <a:endParaRPr lang="fr-F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Accolade fermante 6"/>
          <p:cNvSpPr/>
          <p:nvPr/>
        </p:nvSpPr>
        <p:spPr>
          <a:xfrm>
            <a:off x="8518604" y="1874593"/>
            <a:ext cx="180000" cy="262800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ZoneTexte 7"/>
          <p:cNvSpPr txBox="1"/>
          <p:nvPr/>
        </p:nvSpPr>
        <p:spPr>
          <a:xfrm>
            <a:off x="8618502" y="3042210"/>
            <a:ext cx="122413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ade </a:t>
            </a:r>
          </a:p>
          <a:p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fr-F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Accolade fermante 8"/>
          <p:cNvSpPr/>
          <p:nvPr/>
        </p:nvSpPr>
        <p:spPr>
          <a:xfrm>
            <a:off x="7577106" y="1909097"/>
            <a:ext cx="144000" cy="54000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ZoneTexte 9"/>
          <p:cNvSpPr txBox="1"/>
          <p:nvPr/>
        </p:nvSpPr>
        <p:spPr>
          <a:xfrm>
            <a:off x="7721106" y="2055986"/>
            <a:ext cx="3600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fr-F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Accolade fermante 10"/>
          <p:cNvSpPr/>
          <p:nvPr/>
        </p:nvSpPr>
        <p:spPr>
          <a:xfrm>
            <a:off x="7272767" y="3096985"/>
            <a:ext cx="144000" cy="90000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Accolade fermante 11"/>
          <p:cNvSpPr/>
          <p:nvPr/>
        </p:nvSpPr>
        <p:spPr>
          <a:xfrm>
            <a:off x="6501932" y="4005256"/>
            <a:ext cx="144000" cy="46800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6668825" y="4116145"/>
            <a:ext cx="3600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V</a:t>
            </a:r>
            <a:endParaRPr lang="fr-F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Accolade fermante 13"/>
          <p:cNvSpPr/>
          <p:nvPr/>
        </p:nvSpPr>
        <p:spPr>
          <a:xfrm>
            <a:off x="8329072" y="2554589"/>
            <a:ext cx="144000" cy="54000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ZoneTexte 14"/>
          <p:cNvSpPr txBox="1"/>
          <p:nvPr/>
        </p:nvSpPr>
        <p:spPr>
          <a:xfrm>
            <a:off x="8409788" y="2694389"/>
            <a:ext cx="3600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endParaRPr lang="fr-F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ZoneTexte 15"/>
          <p:cNvSpPr txBox="1"/>
          <p:nvPr/>
        </p:nvSpPr>
        <p:spPr>
          <a:xfrm>
            <a:off x="7407104" y="3423874"/>
            <a:ext cx="3600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II</a:t>
            </a:r>
            <a:endParaRPr lang="fr-F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ZoneTexte 16"/>
          <p:cNvSpPr txBox="1"/>
          <p:nvPr/>
        </p:nvSpPr>
        <p:spPr>
          <a:xfrm>
            <a:off x="107504" y="4934448"/>
            <a:ext cx="8856984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ure 2.  </a:t>
            </a:r>
            <a:r>
              <a:rPr lang="fr-FR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ylogenetic</a:t>
            </a:r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ee</a:t>
            </a:r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ade A of the BAHD </a:t>
            </a:r>
            <a:r>
              <a:rPr lang="fr-FR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erfamily</a:t>
            </a:r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hich</a:t>
            </a:r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fr-FR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posed</a:t>
            </a:r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o </a:t>
            </a:r>
            <a:r>
              <a:rPr lang="fr-FR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ain</a:t>
            </a:r>
            <a:r>
              <a:rPr lang="fr-FR" sz="10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ndidate </a:t>
            </a:r>
            <a:r>
              <a:rPr lang="fr-FR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abinoxylan</a:t>
            </a:r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ruloyltransferases</a:t>
            </a:r>
            <a:r>
              <a: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algn="just"/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tein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uences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ce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rachypodium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ize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igned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stal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ga, the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ignment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dited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blocks0.91b, the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ee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structed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hyML3.0 and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rawn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endroscope3.5.7.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umbers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n the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ee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des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re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ootstrap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nfidence values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ased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n 100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ootstrap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terations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The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cale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ar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s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0.1 substitution per site.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ce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uences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amed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s in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artley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et al. (2013) :OsAT6 LOC_Os01g08380.1; OsAT9 LOC_Os01g09010.1 ; OsAT4/PMT  LOC_Os01g18744.1 ; OsAT2  LOC_Os01g42870.1 ; OsAT1 LOC_Os01g42880.1 ; OsAT19  LOC_Os04g09260.1 ; OsAT12 LOC_Os04g09590.1; OsAT11  LOC_Os04g11810.1; OsAT3 LOC_Os05g04584.1 ; OsAT7 LOC_Os05g08640.1 ; OsAT5 LOC_Os05g19910.1 ; OsAT10 LOC_Os06g39390.1; OsAT8 LOC_Os06g39470.1 ; OsAT20 LOC_Os06g48560.1 ; OsAT15 LOC_Os10g01920.1; OsAT13 LOC_Os10g01930.1 ; OsAT17 LOC_Os10g03360.1. Clades A and B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scribed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linari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et al. (2013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ade B </a:t>
            </a:r>
            <a:r>
              <a:rPr lang="fr-F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s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presented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out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otstrap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alues for illustration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ly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none of the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ize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s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in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is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lade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ed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the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ricarp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; Groups I III IV V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scribed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Piston et al. (2010) and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uanafina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et al. (2015). </a:t>
            </a:r>
            <a:endParaRPr lang="fr-F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Connecteur droit 18"/>
          <p:cNvCxnSpPr/>
          <p:nvPr/>
        </p:nvCxnSpPr>
        <p:spPr>
          <a:xfrm>
            <a:off x="107504" y="386413"/>
            <a:ext cx="72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4321160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F3304DEAE09B24DA68D64CBB702879E" ma:contentTypeVersion="7" ma:contentTypeDescription="Create a new document." ma:contentTypeScope="" ma:versionID="56f4917bd8fe5572caa8ce3e64525f08">
  <xsd:schema xmlns:xsd="http://www.w3.org/2001/XMLSchema" xmlns:p="http://schemas.microsoft.com/office/2006/metadata/properties" xmlns:ns2="28de4f29-e3d9-478e-b05a-16a8ff0eb393" targetNamespace="http://schemas.microsoft.com/office/2006/metadata/properties" ma:root="true" ma:fieldsID="90fc53ae50983f9ac236714ed868e368" ns2:_="">
    <xsd:import namespace="28de4f29-e3d9-478e-b05a-16a8ff0eb393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28de4f29-e3d9-478e-b05a-16a8ff0eb393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Id xmlns="28de4f29-e3d9-478e-b05a-16a8ff0eb393">Presentation 2.PPTX</DocumentId>
    <StageName xmlns="28de4f29-e3d9-478e-b05a-16a8ff0eb393" xsi:nil="true"/>
    <IsDeleted xmlns="28de4f29-e3d9-478e-b05a-16a8ff0eb393">false</IsDeleted>
    <FileFormat xmlns="28de4f29-e3d9-478e-b05a-16a8ff0eb393">PPTX</FileFormat>
    <TitleName xmlns="28de4f29-e3d9-478e-b05a-16a8ff0eb393">Presentation 2.PPTX</TitleName>
    <DocumentType xmlns="28de4f29-e3d9-478e-b05a-16a8ff0eb393">Presentation</DocumentType>
    <Checked_x0020_Out_x0020_To xmlns="28de4f29-e3d9-478e-b05a-16a8ff0eb393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39C5B075-BF63-4251-BF1F-3CD14479BD7C}"/>
</file>

<file path=customXml/itemProps2.xml><?xml version="1.0" encoding="utf-8"?>
<ds:datastoreItem xmlns:ds="http://schemas.openxmlformats.org/officeDocument/2006/customXml" ds:itemID="{EA8173F6-65AD-4951-851C-6A45F84A8435}"/>
</file>

<file path=customXml/itemProps3.xml><?xml version="1.0" encoding="utf-8"?>
<ds:datastoreItem xmlns:ds="http://schemas.openxmlformats.org/officeDocument/2006/customXml" ds:itemID="{EBD77A0F-B265-45A6-895E-B72E0B068273}"/>
</file>

<file path=docProps/app.xml><?xml version="1.0" encoding="utf-8"?>
<Properties xmlns="http://schemas.openxmlformats.org/officeDocument/2006/extended-properties" xmlns:vt="http://schemas.openxmlformats.org/officeDocument/2006/docPropsVTypes">
  <TotalTime>195</TotalTime>
  <Words>215</Words>
  <Application>Microsoft Office PowerPoint</Application>
  <PresentationFormat>Affichage à l'écran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INR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lchateigner</dc:creator>
  <cp:lastModifiedBy>alchateigner</cp:lastModifiedBy>
  <cp:revision>13</cp:revision>
  <cp:lastPrinted>2016-06-28T15:14:06Z</cp:lastPrinted>
  <dcterms:created xsi:type="dcterms:W3CDTF">2016-06-28T12:08:49Z</dcterms:created>
  <dcterms:modified xsi:type="dcterms:W3CDTF">2016-08-26T12:16:09Z</dcterms:modified>
</cp:coreProperties>
</file>